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99"/>
    <p:restoredTop sz="95313"/>
  </p:normalViewPr>
  <p:slideViewPr>
    <p:cSldViewPr snapToGrid="0" snapToObjects="1">
      <p:cViewPr varScale="1">
        <p:scale>
          <a:sx n="93" d="100"/>
          <a:sy n="93" d="100"/>
        </p:scale>
        <p:origin x="200" y="3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4696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63445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2811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96983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4635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29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1187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6902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27362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206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78548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3E15CA-714F-7745-AAA2-78FA4B457108}" type="datetimeFigureOut">
              <a:rPr kumimoji="1" lang="ja-JP" altLang="en-US" smtClean="0"/>
              <a:t>2020/8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97C3C-7A73-C04C-9E88-F86C475FB2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239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F1CB9EA-4CB1-8046-85A2-56A88BCF9E2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0177174"/>
              </p:ext>
            </p:extLst>
          </p:nvPr>
        </p:nvGraphicFramePr>
        <p:xfrm>
          <a:off x="1413163" y="1023952"/>
          <a:ext cx="6179127" cy="44763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73736">
                  <a:extLst>
                    <a:ext uri="{9D8B030D-6E8A-4147-A177-3AD203B41FA5}">
                      <a16:colId xmlns:a16="http://schemas.microsoft.com/office/drawing/2014/main" val="983586266"/>
                    </a:ext>
                  </a:extLst>
                </a:gridCol>
                <a:gridCol w="1512440">
                  <a:extLst>
                    <a:ext uri="{9D8B030D-6E8A-4147-A177-3AD203B41FA5}">
                      <a16:colId xmlns:a16="http://schemas.microsoft.com/office/drawing/2014/main" val="1651397428"/>
                    </a:ext>
                  </a:extLst>
                </a:gridCol>
                <a:gridCol w="1292951">
                  <a:extLst>
                    <a:ext uri="{9D8B030D-6E8A-4147-A177-3AD203B41FA5}">
                      <a16:colId xmlns:a16="http://schemas.microsoft.com/office/drawing/2014/main" val="2161930350"/>
                    </a:ext>
                  </a:extLst>
                </a:gridCol>
              </a:tblGrid>
              <a:tr h="312300">
                <a:tc rowSpan="2"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4551099"/>
                  </a:ext>
                </a:extLst>
              </a:tr>
              <a:tr h="3123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st trimest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rd trimester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3565680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indent="153035" algn="just">
                        <a:spcAft>
                          <a:spcPts val="0"/>
                        </a:spcAft>
                      </a:pPr>
                      <a:r>
                        <a:rPr lang="en-US" sz="1200" u="sng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sease activity parameter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16676175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No achievement of LLDAS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1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00192597"/>
                  </a:ext>
                </a:extLst>
              </a:tr>
              <a:tr h="52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No achievement of LLDA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without glucocorticoid dos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5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45184145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SLEDAI scor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2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4991437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3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57760381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4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34108330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CH50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9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8588551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Titer of anti-dsDNA antibody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*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16467754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indent="153035" algn="just">
                        <a:spcAft>
                          <a:spcPts val="0"/>
                        </a:spcAft>
                      </a:pPr>
                      <a:r>
                        <a:rPr lang="en-US" sz="1200" u="sng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reatment agents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87531690"/>
                  </a:ext>
                </a:extLst>
              </a:tr>
              <a:tr h="3123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Glucocorticoid use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0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200237"/>
                  </a:ext>
                </a:extLst>
              </a:tr>
              <a:tr h="520500">
                <a:tc>
                  <a:txBody>
                    <a:bodyPr/>
                    <a:lstStyle/>
                    <a:p>
                      <a:pPr indent="304800"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 prednisolone dose during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pregnancy</a:t>
                      </a:r>
                      <a:r>
                        <a:rPr lang="ja-JP" sz="1200" kern="1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＃＃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ja-JP" sz="12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ja-JP" sz="1200" kern="100"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6603510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938E355-A31A-9748-BB60-805268256211}"/>
              </a:ext>
            </a:extLst>
          </p:cNvPr>
          <p:cNvSpPr txBox="1"/>
          <p:nvPr/>
        </p:nvSpPr>
        <p:spPr>
          <a:xfrm>
            <a:off x="858982" y="471055"/>
            <a:ext cx="5153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1. Relevance to preterm birth</a:t>
            </a:r>
            <a:r>
              <a:rPr lang="ja-JP" altLang="ja-JP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06EA4D1-394C-E74D-8B89-6AE13A03FBA1}"/>
              </a:ext>
            </a:extLst>
          </p:cNvPr>
          <p:cNvSpPr txBox="1"/>
          <p:nvPr/>
        </p:nvSpPr>
        <p:spPr>
          <a:xfrm>
            <a:off x="1080655" y="5614554"/>
            <a:ext cx="707967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isher’s exact test,  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Wilcoxon rank sum test, *; P&lt;0.05. SLEDAI; systemic lupus erythematosus disease activity index, LLDAS; lupus low disease activity state, anti-dsDNA antibody; anti-double stranded DNA antibody)</a:t>
            </a:r>
            <a:r>
              <a:rPr lang="ja-JP" altLang="ja-JP" sz="120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23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32</Words>
  <Application>Microsoft Macintosh PowerPoint</Application>
  <PresentationFormat>画面に合わせる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User</dc:creator>
  <cp:lastModifiedBy>Microsoft Office User</cp:lastModifiedBy>
  <cp:revision>3</cp:revision>
  <dcterms:created xsi:type="dcterms:W3CDTF">2020-05-14T06:26:30Z</dcterms:created>
  <dcterms:modified xsi:type="dcterms:W3CDTF">2020-08-01T02:35:34Z</dcterms:modified>
</cp:coreProperties>
</file>